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embeddings/oleObject2.xlsx" ContentType="application/vnd.openxmlformats-officedocument.spreadsheetml.sheet"/>
  <Override PartName="/ppt/media/image1.pct" ContentType="image/x-pict"/>
  <Override PartName="/ppt/media/image2.pct" ContentType="image/x-pict"/>
  <Override PartName="/ppt/media/image3.pct" ContentType="image/x-pict"/>
  <Override PartName="/ppt/media/image4.pct" ContentType="image/x-pict"/>
  <Override PartName="/ppt/media/image5.pct" ContentType="image/x-pict"/>
  <Override PartName="/ppt/media/image6.pct" ContentType="image/x-pi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55569-1281-4747-AF4C-38B4CF7422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BA8B12-154E-4D18-A688-53DBD2CB1D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7BAC9-451F-48AC-BCE2-70BB19898B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7458D-D4FB-418B-B39A-865995983E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4C148-88E4-49B4-8ECF-9BFDF91E67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FFF88-42DC-4B48-AE36-46C760339A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9CC26C-89DB-4972-BFE0-4740D237C5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16CE0-15E7-452B-9015-2832FDE42E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B72A86-181B-469D-8006-7217953F45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360B7F-3BC0-4D52-8469-0287D73609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3E8AA-D142-4F1A-B9E3-CB813CCBB9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B1B588-1BEA-40D3-85E1-1D14420BBE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2189BB-80B5-4EC3-9CD7-4C8FE749AC99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pct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2.pct"/><Relationship Id="rId3" Type="http://schemas.openxmlformats.org/officeDocument/2006/relationships/package" Target="../embeddings/oleObject2.xlsx"/><Relationship Id="rId4" Type="http://schemas.openxmlformats.org/officeDocument/2006/relationships/image" Target="../media/image3.pct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4.pct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5.pct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6.pct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73120" y="685800"/>
          <a:ext cx="6197760" cy="381312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73120" y="685800"/>
                    <a:ext cx="6197760" cy="381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0" y="6087960"/>
            <a:ext cx="8077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Supplementary Fig.1: oligonucleotide primer sequenc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383040" y="330120"/>
            <a:ext cx="8411040" cy="57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Arial"/>
              </a:rPr>
              <a:t>ampicillin fragmen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CCA CTG AGC GTC AGA CCC CGT AGA AAA GAT CAA AGG ATC TTC TTG AGA TCC TTT TTT TCT GCG CGT AAT CTG CTG CTT GCA AAC AAA A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10           20           30            40           50           60            70           80           9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CC ACC GCT ACC AGC GGT GGT TTG TTT GCC GGA TCA AGA GCT ACC AAC TCT TTT TCC GAA GGT AAC TGG CTT CAG CAG AGC GCA GAT AC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100          110          120           130          140          150           160          170          1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AA TAC TGT CCT TCT AGT GTA GCC GTA GTT AGG CCA CCA CTT CAA GAA CTC TGT AGC ACC GCC TAC ATA CCT CGC TCT GCT AAT CCT GT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190          200          210           220          230          240           250          260          27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CC AGT GGC TGC TGC CAG TGG CGA TAA GTC GTG TCT TAC CGG GTT GGA CTC AAG ACG ATA GTT ACC GGA TAA GGC GCA GCG GTC GGG CT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280          290          300           310          320          330           340          350          36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AC GGG GGG TTC GTG CAC ACA GCC CAG CTT GGA GCG AAC GAC CTA CAC CGA ACT GAG ATA CCT ACA GCG TGA GCT ATG AGA AAG CGC CA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370          380          390           400          410          420           430          440          45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                         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 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i="1" lang="de-DE" sz="9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GCT TCC CGA AGG GAG AAA GGC GGA CAG GTA TCC GGT AAG CGG CAG GGT CGG AAC AGG AGA GCG CAC GAG GGA GCT TCC AGG GGG AAA CG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460          470          480           490          500          510           520          530          54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                                               A               A                    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CTG GTA TCT TTA TAG TCC TGT CGG GTT TCG CCA CCT CTG ACT TGA GCG TCG ATT TTT GTG ATG CTC GTC AGG GGG GCG GAG CCT ATG G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550          560          570           580          590          600           610          620          6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     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Arial"/>
              </a:rPr>
              <a:t>EGFP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1" lang="de-DE" sz="900" spc="-1" strike="noStrike">
                <a:solidFill>
                  <a:srgbClr val="000000"/>
                </a:solidFill>
                <a:latin typeface="Arial"/>
              </a:rPr>
              <a:t>lacZ gen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AA CGC CAG CAA CGC GGC CTT TCG TGC GGG AGA CTG CGG GAG ACG TCG AGT CCA ACC CTC TAG CTG CA*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*** *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** TAA AGC GGC CGC GG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640          650          660           670          680          690           700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710          7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"/>
          <p:cNvSpPr/>
          <p:nvPr/>
        </p:nvSpPr>
        <p:spPr>
          <a:xfrm>
            <a:off x="0" y="5942160"/>
            <a:ext cx="9144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. 2: Point mutations found after FV vector transfer. The vectors were produced in the absence or presence (mutations in bold face) of Bet protein. The two A to G transitions are in italic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49920" y="152280"/>
            <a:ext cx="841068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A                       AA             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A              A       A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TTT ACA CTT TAT GCT TCC GGC TCG TAT GTT GTG TGG AAT TGT GAG CGG ATA ACA ATT TCA CAC AGG AAA CAG CTA TGA CCA TGA TTA CG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730          740          750           760          770          780           790          800          8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                A                                  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                A                                  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                    A    A            A          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i="1" lang="de-DE" sz="9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A    A          A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                 A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A           A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CAA GCT TGC ATG CCT GCA GGT CGA CTC TAG AGG ATC CCC GGG TAC CGA GCT CGA ATT CAC TGG CCG TCG TTT TAC AAC GTC GTG ACT GG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820          830          840           850          860          870           880          890          9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AA ACC CTG GCG TTA CCC AAC TTA ATC GCC TTG CAG CAC ATC CCC CTT TCG CCA GCT GGC GTA ATA GCG AAG AGG CCC GCA CCG ATC GC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910          920          930           940          950          960           970          980          99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                                          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                                                  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CTT CCC AAC AGT TGC GCA GCC TGA ATG GCG AAT GGC GCC TGA TGC GGT ATT TTC TCC TTA CGC ATC TGT GCG GTA TTT CAC ACC GCA TA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1000         1010         1020          1030         1040         1050          1060         1070         10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A                 A   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 A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GGT GCA CTC TCA GTA CAA TCT GCT CTG ATG CCG CAT AGT TAA GCC AGC CCC GAC ACC CGC CAA CCT CGA GGC GGC CGC GAC TCT AGG GG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     .             .            .            .             .            .            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1090         1100         1110          1120         1130         1140          1150         1160         117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1" lang="de-DE" sz="9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TTC GCG ATA AGT AAG TAA GCT TAT 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.            .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          </a:t>
            </a:r>
            <a:r>
              <a:rPr b="0" lang="de-DE" sz="900" spc="-1" strike="noStrike">
                <a:solidFill>
                  <a:srgbClr val="000000"/>
                </a:solidFill>
                <a:latin typeface="Courier New"/>
              </a:rPr>
              <a:t>1180         1190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60480" y="6216480"/>
            <a:ext cx="9083520" cy="73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. 3: Level of human APOBEC3F (A3F) mRNA expression in 293T cells in relation to PBMCs.</a:t>
            </a: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0" y="1219320"/>
          <a:ext cx="5670720" cy="341460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219320"/>
                    <a:ext cx="5670720" cy="3414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"/>
          <p:cNvGraphicFramePr/>
          <p:nvPr/>
        </p:nvGraphicFramePr>
        <p:xfrm>
          <a:off x="5943600" y="1295280"/>
          <a:ext cx="2844720" cy="35308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1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943600" y="1295280"/>
                    <a:ext cx="2844720" cy="3530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"/>
          <p:cNvSpPr/>
          <p:nvPr/>
        </p:nvSpPr>
        <p:spPr>
          <a:xfrm>
            <a:off x="0" y="609588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. 4: One deletion detected among over 265,000 nucleotides analyse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152280" y="1762200"/>
          <a:ext cx="8991720" cy="244944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2280" y="1762200"/>
                    <a:ext cx="8991720" cy="2449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"/>
          <p:cNvSpPr/>
          <p:nvPr/>
        </p:nvSpPr>
        <p:spPr>
          <a:xfrm>
            <a:off x="0" y="6019920"/>
            <a:ext cx="914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. 5: Number of colonies resistant to Hygro and/or Neo upon transfer of MLV vecto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1662120" y="1967040"/>
          <a:ext cx="5819760" cy="292248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5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62120" y="1967040"/>
                    <a:ext cx="5819760" cy="2922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"/>
          <p:cNvGraphicFramePr/>
          <p:nvPr/>
        </p:nvGraphicFramePr>
        <p:xfrm>
          <a:off x="1662120" y="2314440"/>
          <a:ext cx="5819760" cy="222732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5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62120" y="2314440"/>
                    <a:ext cx="5819760" cy="2227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"/>
          <p:cNvSpPr/>
          <p:nvPr/>
        </p:nvSpPr>
        <p:spPr>
          <a:xfrm>
            <a:off x="0" y="5943600"/>
            <a:ext cx="9144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. 6: Number of colonies resistant to Hygro and/or Neo upon transfer of PFV vecto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17T08:46:19Z</dcterms:created>
  <dc:creator>Axel Rethwilm</dc:creator>
  <dc:description/>
  <dc:language>en-US</dc:language>
  <cp:lastModifiedBy>Kristin Kaufmann</cp:lastModifiedBy>
  <dcterms:modified xsi:type="dcterms:W3CDTF">2008-11-03T13:06:46Z</dcterms:modified>
  <cp:revision>8</cp:revision>
  <dc:subject/>
  <dc:title>PowerPoint-Präsentation</dc:title>
</cp:coreProperties>
</file>